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62" r:id="rId3"/>
    <p:sldId id="263" r:id="rId4"/>
    <p:sldId id="259" r:id="rId5"/>
    <p:sldId id="260" r:id="rId6"/>
    <p:sldId id="261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0" d="100"/>
          <a:sy n="110" d="100"/>
        </p:scale>
        <p:origin x="-164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9044D-6FC6-404E-BBEB-A700C1D2B248}" type="datetimeFigureOut">
              <a:rPr lang="zh-CN" altLang="en-US" smtClean="0"/>
              <a:t>2018/12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39524-3574-49FD-BCD5-C3E106508F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34094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9044D-6FC6-404E-BBEB-A700C1D2B248}" type="datetimeFigureOut">
              <a:rPr lang="zh-CN" altLang="en-US" smtClean="0"/>
              <a:t>2018/12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39524-3574-49FD-BCD5-C3E106508F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90152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9044D-6FC6-404E-BBEB-A700C1D2B248}" type="datetimeFigureOut">
              <a:rPr lang="zh-CN" altLang="en-US" smtClean="0"/>
              <a:t>2018/12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39524-3574-49FD-BCD5-C3E106508F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97567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9044D-6FC6-404E-BBEB-A700C1D2B248}" type="datetimeFigureOut">
              <a:rPr lang="zh-CN" altLang="en-US" smtClean="0"/>
              <a:t>2018/12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39524-3574-49FD-BCD5-C3E106508F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32233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9044D-6FC6-404E-BBEB-A700C1D2B248}" type="datetimeFigureOut">
              <a:rPr lang="zh-CN" altLang="en-US" smtClean="0"/>
              <a:t>2018/12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39524-3574-49FD-BCD5-C3E106508F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744036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9044D-6FC6-404E-BBEB-A700C1D2B248}" type="datetimeFigureOut">
              <a:rPr lang="zh-CN" altLang="en-US" smtClean="0"/>
              <a:t>2018/12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39524-3574-49FD-BCD5-C3E106508F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0825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9044D-6FC6-404E-BBEB-A700C1D2B248}" type="datetimeFigureOut">
              <a:rPr lang="zh-CN" altLang="en-US" smtClean="0"/>
              <a:t>2018/12/2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39524-3574-49FD-BCD5-C3E106508F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52088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9044D-6FC6-404E-BBEB-A700C1D2B248}" type="datetimeFigureOut">
              <a:rPr lang="zh-CN" altLang="en-US" smtClean="0"/>
              <a:t>2018/12/2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39524-3574-49FD-BCD5-C3E106508F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91183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9044D-6FC6-404E-BBEB-A700C1D2B248}" type="datetimeFigureOut">
              <a:rPr lang="zh-CN" altLang="en-US" smtClean="0"/>
              <a:t>2018/12/2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39524-3574-49FD-BCD5-C3E106508F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17021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9044D-6FC6-404E-BBEB-A700C1D2B248}" type="datetimeFigureOut">
              <a:rPr lang="zh-CN" altLang="en-US" smtClean="0"/>
              <a:t>2018/12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39524-3574-49FD-BCD5-C3E106508F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76079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9044D-6FC6-404E-BBEB-A700C1D2B248}" type="datetimeFigureOut">
              <a:rPr lang="zh-CN" altLang="en-US" smtClean="0"/>
              <a:t>2018/12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39524-3574-49FD-BCD5-C3E106508F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13034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D9044D-6FC6-404E-BBEB-A700C1D2B248}" type="datetimeFigureOut">
              <a:rPr lang="zh-CN" altLang="en-US" smtClean="0"/>
              <a:t>2018/12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239524-3574-49FD-BCD5-C3E106508F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98891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:a16="http://schemas.microsoft.com/office/drawing/2014/main" xmlns="" id="{872DE224-95DA-4CE2-942A-F15D3306DF41}"/>
              </a:ext>
            </a:extLst>
          </p:cNvPr>
          <p:cNvSpPr/>
          <p:nvPr/>
        </p:nvSpPr>
        <p:spPr>
          <a:xfrm>
            <a:off x="744426" y="3784184"/>
            <a:ext cx="7389845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2400"/>
              </a:lnSpc>
              <a:spcAft>
                <a:spcPts val="0"/>
              </a:spcAft>
            </a:pP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ensitivity analysis of HIF1A rs2057482</a:t>
            </a:r>
            <a:endParaRPr lang="zh-CN" altLang="zh-CN" sz="2400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7F21BC45-8785-427F-B815-7FD1ABB919D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864" b="40272"/>
          <a:stretch/>
        </p:blipFill>
        <p:spPr>
          <a:xfrm>
            <a:off x="526399" y="1035696"/>
            <a:ext cx="8091202" cy="21367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093125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CAAD7A01-CB02-4A40-AFDA-4F57C137646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456" b="40272"/>
          <a:stretch/>
        </p:blipFill>
        <p:spPr>
          <a:xfrm>
            <a:off x="1197100" y="1464907"/>
            <a:ext cx="6749800" cy="1819469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xmlns="" id="{9EE54638-1AD8-4955-B9AE-CB706E93C4A6}"/>
              </a:ext>
            </a:extLst>
          </p:cNvPr>
          <p:cNvSpPr/>
          <p:nvPr/>
        </p:nvSpPr>
        <p:spPr>
          <a:xfrm>
            <a:off x="877077" y="3662887"/>
            <a:ext cx="7389845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2400"/>
              </a:lnSpc>
              <a:spcAft>
                <a:spcPts val="0"/>
              </a:spcAft>
            </a:pP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meta analysis of HIF1A rs2057482 in Caucasians.</a:t>
            </a:r>
            <a:endParaRPr lang="zh-CN" altLang="zh-CN" sz="2400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553118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EFB59A66-228F-4DCA-B708-C18361C4E5A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640" b="38639"/>
          <a:stretch/>
        </p:blipFill>
        <p:spPr>
          <a:xfrm>
            <a:off x="912308" y="1087330"/>
            <a:ext cx="7319384" cy="2211355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xmlns="" id="{ED36CB5E-3BAE-42CB-B697-F10F9874E6B1}"/>
              </a:ext>
            </a:extLst>
          </p:cNvPr>
          <p:cNvSpPr/>
          <p:nvPr/>
        </p:nvSpPr>
        <p:spPr>
          <a:xfrm>
            <a:off x="1180322" y="3671283"/>
            <a:ext cx="6783356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2400"/>
              </a:lnSpc>
              <a:spcAft>
                <a:spcPts val="0"/>
              </a:spcAft>
            </a:pP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meta analysis of HIF1A rs2057482 in Asian.</a:t>
            </a:r>
            <a:endParaRPr lang="zh-CN" altLang="zh-CN" sz="2400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466976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:a16="http://schemas.microsoft.com/office/drawing/2014/main" xmlns="" id="{872DE224-95DA-4CE2-942A-F15D3306DF41}"/>
              </a:ext>
            </a:extLst>
          </p:cNvPr>
          <p:cNvSpPr/>
          <p:nvPr/>
        </p:nvSpPr>
        <p:spPr>
          <a:xfrm>
            <a:off x="744426" y="3784184"/>
            <a:ext cx="7389845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2400"/>
              </a:lnSpc>
              <a:spcAft>
                <a:spcPts val="0"/>
              </a:spcAft>
            </a:pPr>
            <a:r>
              <a:rPr lang="en-US" altLang="zh-CN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meta analysis of HIF1A rs10873142</a:t>
            </a:r>
            <a:endParaRPr lang="zh-CN" altLang="zh-CN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xmlns="" id="{197C8738-02FF-4583-B146-6C42F0CBBA9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361" b="41769"/>
          <a:stretch/>
        </p:blipFill>
        <p:spPr>
          <a:xfrm>
            <a:off x="406503" y="1399590"/>
            <a:ext cx="8507508" cy="19081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374612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:a16="http://schemas.microsoft.com/office/drawing/2014/main" xmlns="" id="{872DE224-95DA-4CE2-942A-F15D3306DF41}"/>
              </a:ext>
            </a:extLst>
          </p:cNvPr>
          <p:cNvSpPr/>
          <p:nvPr/>
        </p:nvSpPr>
        <p:spPr>
          <a:xfrm>
            <a:off x="744426" y="3784184"/>
            <a:ext cx="7389845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2400"/>
              </a:lnSpc>
              <a:spcAft>
                <a:spcPts val="0"/>
              </a:spcAft>
            </a:pPr>
            <a:r>
              <a:rPr lang="en-US" altLang="zh-CN" kern="1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meta analysis of HIF1A </a:t>
            </a:r>
            <a:r>
              <a:rPr lang="zh-CN" altLang="zh-CN" dirty="0"/>
              <a:t>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11549467</a:t>
            </a:r>
            <a:endParaRPr lang="zh-CN" altLang="zh-CN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xmlns="" id="{119066F7-400E-4BB3-A468-99051497829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0817" b="40816"/>
          <a:stretch/>
        </p:blipFill>
        <p:spPr>
          <a:xfrm>
            <a:off x="540659" y="1460241"/>
            <a:ext cx="8062681" cy="19687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787927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:a16="http://schemas.microsoft.com/office/drawing/2014/main" xmlns="" id="{872DE224-95DA-4CE2-942A-F15D3306DF41}"/>
              </a:ext>
            </a:extLst>
          </p:cNvPr>
          <p:cNvSpPr/>
          <p:nvPr/>
        </p:nvSpPr>
        <p:spPr>
          <a:xfrm>
            <a:off x="744426" y="3784184"/>
            <a:ext cx="7389845" cy="38260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2400"/>
              </a:lnSpc>
              <a:spcAft>
                <a:spcPts val="0"/>
              </a:spcAft>
            </a:pP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6 The meta analysis of HIF1A </a:t>
            </a:r>
            <a:r>
              <a:rPr lang="zh-CN" altLang="zh-CN" dirty="0"/>
              <a:t> 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s41508050</a:t>
            </a:r>
            <a:endParaRPr lang="zh-CN" altLang="zh-CN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C0BE375D-DE0B-4241-B3E2-5C2AE2FCB2F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2041" b="42041"/>
          <a:stretch/>
        </p:blipFill>
        <p:spPr>
          <a:xfrm>
            <a:off x="550214" y="1371599"/>
            <a:ext cx="8043572" cy="17022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723529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6</TotalTime>
  <Words>55</Words>
  <Application>Microsoft Office PowerPoint</Application>
  <PresentationFormat>On-screen Show (4:3)</PresentationFormat>
  <Paragraphs>6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李亦兰</dc:creator>
  <cp:lastModifiedBy>DBALINDAN</cp:lastModifiedBy>
  <cp:revision>37</cp:revision>
  <dcterms:created xsi:type="dcterms:W3CDTF">2018-03-07T08:54:49Z</dcterms:created>
  <dcterms:modified xsi:type="dcterms:W3CDTF">2018-12-29T11:56:28Z</dcterms:modified>
</cp:coreProperties>
</file>